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1" autoAdjust="0"/>
    <p:restoredTop sz="94660"/>
  </p:normalViewPr>
  <p:slideViewPr>
    <p:cSldViewPr snapToGrid="0">
      <p:cViewPr varScale="1">
        <p:scale>
          <a:sx n="94" d="100"/>
          <a:sy n="94" d="100"/>
        </p:scale>
        <p:origin x="53" y="25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01DA20-8FB4-4CC4-96F1-E0313543BD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339AA82-56FE-4ED8-8F9A-4B25690C915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C2BA0B-6837-46DF-89E6-A0CA38711A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5F540-4C2B-423E-B936-0C259760DCEB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D7F1F8-767C-4E4A-8C31-A6BE89C34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363A99-C519-4005-B249-0700F83B39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0249-909F-4121-8F23-05B057DB0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90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D4691B-0DE9-4304-8B62-BDFEF6EBB4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D003CD-A632-456C-8D02-3DB4C93286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23B425-E160-46D7-AED6-6BD01EB66A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5F540-4C2B-423E-B936-0C259760DCEB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C11BA7-ED99-4D03-81B5-24991911C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850D2C-F2B0-482B-BD26-B579E34A9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0249-909F-4121-8F23-05B057DB0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991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46AD781-9B69-4D92-9B1C-7E5163C3AF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FCDA0B-C795-4FA1-A588-6021D7EDF8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328DE3-E675-4EDB-A5FE-976973B829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5F540-4C2B-423E-B936-0C259760DCEB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EF9E26-F522-4E7C-94A3-AFB5FB7921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43025D-90FE-4C2E-A147-7AADEC2E7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0249-909F-4121-8F23-05B057DB0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922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EB4F67-1046-4A99-9571-5C37E502AE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E232D5-5DDB-42D0-B153-8B33C6CD9C2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17FD8B-3296-4E3B-BC7A-24CF77FB9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5F540-4C2B-423E-B936-0C259760DCEB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B8C6E6-1DEE-4937-8F62-ED215A9197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11B7AA-577A-4649-AAD7-6A25038FCC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0249-909F-4121-8F23-05B057DB0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530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9763A6-BEF8-46BD-98FE-093B6AC5B1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276B23-4CE8-42E2-9F6B-F4B74C75B3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0A1903-EA2D-457E-A018-B0276189D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5F540-4C2B-423E-B936-0C259760DCEB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2D5D72-793A-4B55-9B20-8359BE6C4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DA5F77-165D-45D4-ADC7-694605BBA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0249-909F-4121-8F23-05B057DB0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1859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36548E-2ED6-440E-A2BD-BFEC111E9E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AC41E4-E737-46D2-9CC8-32C9CABD9C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FEDA67-879E-4DB8-908F-A99CFB6112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295F46-82F5-4762-A416-8F01166F5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5F540-4C2B-423E-B936-0C259760DCEB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1F8FAD-0FB7-4A48-AB0B-D6921FD95D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9AEC11-1178-4CFA-A37B-72E1281CB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0249-909F-4121-8F23-05B057DB0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8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E34E75-5F97-471B-850A-7B3F5921C1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176DA4-BDD7-4124-93EB-28FC04558D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9A4CC9-E222-48CB-BCF5-AA08D47075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C1395D-C367-4684-BA0C-A4D1525448C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3D6D4A2-80D1-4A4F-BDBB-6F08EE3D00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2B09E06-A682-4FB2-8FE1-F4FD2925A9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5F540-4C2B-423E-B936-0C259760DCEB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1218B21-B893-4A5C-BA6A-D7BBE2DF5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3940D3B-86B3-46FC-9263-0D00EB57B2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0249-909F-4121-8F23-05B057DB0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5754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957B7-AF8F-43FA-B783-65D4A29813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D72BD41-AEE0-4E19-B680-2EBB8B811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5F540-4C2B-423E-B936-0C259760DCEB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25BA1D8-0AFE-488A-AEF7-8D732BF8D0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6D0011-EEC6-4FE1-8973-7B9C9958D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0249-909F-4121-8F23-05B057DB0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645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8194FDD-7A53-4868-B066-52F9D50CD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5F540-4C2B-423E-B936-0C259760DCEB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8690C7B-CAE6-469A-9084-AF34B09B58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AEF8BBB-CABE-4D9B-A0E5-793DA1B035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0249-909F-4121-8F23-05B057DB0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22005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DD34D5-8F21-4DE5-861E-7D242010FD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4EBE69-A1B8-4658-A3BE-77429D4605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2EDBF3-B267-48D0-8D00-72F3EA4A73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52D780-1B67-4600-9E9F-F2782BC3F9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5F540-4C2B-423E-B936-0C259760DCEB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4EC358-2B66-424E-AD44-57EF2BF5DF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6B85AE-D436-41BC-B4B1-8D6052A0F6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0249-909F-4121-8F23-05B057DB0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751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BE9980-8F3D-4C9B-AFEA-6163081E3A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10AC218-BB97-4D0A-A084-A1A4F1DBF9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D825399-AE96-45D4-973A-5001EB88A1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879B8D-711E-4027-877B-0B284F6090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5F540-4C2B-423E-B936-0C259760DCEB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1FFB9E-48A6-4E98-A9C5-BBD4346778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068849-7B3A-434C-8D05-1663FC366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0249-909F-4121-8F23-05B057DB0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923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CFB537-88FE-408C-95D0-CA14346589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A6169F-B653-492E-AD02-D800102A36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A190D4-72DD-4548-BFF7-67D58EA69F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F5F540-4C2B-423E-B936-0C259760DCEB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C0A970-B07C-4CF4-BC97-B8F5EEB867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F8930C-05CE-4D57-A70C-094F793C28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D60249-909F-4121-8F23-05B057DB0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0035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microsoft.com/office/2007/relationships/hdphoto" Target="../media/hdphoto1.wdp"/><Relationship Id="rId7" Type="http://schemas.openxmlformats.org/officeDocument/2006/relationships/image" Target="../media/image5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4A89285-7593-4AD3-97F6-CF38D2429107}"/>
              </a:ext>
            </a:extLst>
          </p:cNvPr>
          <p:cNvPicPr preferRelativeResize="0"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78000"/>
                    </a14:imgEffect>
                    <a14:imgEffect>
                      <a14:brightnessContrast contrast="2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103" t="11727" r="-1" b="11501"/>
          <a:stretch/>
        </p:blipFill>
        <p:spPr>
          <a:xfrm>
            <a:off x="9578964" y="297412"/>
            <a:ext cx="2321172" cy="201168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93132E0-EFCB-4FFB-B88F-93382E996201}"/>
              </a:ext>
            </a:extLst>
          </p:cNvPr>
          <p:cNvPicPr preferRelativeResize="0"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71" t="11739" b="3265"/>
          <a:stretch/>
        </p:blipFill>
        <p:spPr>
          <a:xfrm>
            <a:off x="9578964" y="2382828"/>
            <a:ext cx="2321172" cy="201168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EC7C0B1-ECC7-4BC1-BFDC-C6947A079A52}"/>
              </a:ext>
            </a:extLst>
          </p:cNvPr>
          <p:cNvPicPr preferRelativeResize="0"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63" t="19684" r="31946" b="18436"/>
          <a:stretch/>
        </p:blipFill>
        <p:spPr>
          <a:xfrm>
            <a:off x="5021046" y="356513"/>
            <a:ext cx="3840480" cy="230428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5AAB930-C837-4067-879D-476C68037D05}"/>
              </a:ext>
            </a:extLst>
          </p:cNvPr>
          <p:cNvPicPr preferRelativeResize="0"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55" t="21504" r="22541" b="23625"/>
          <a:stretch/>
        </p:blipFill>
        <p:spPr>
          <a:xfrm>
            <a:off x="5021046" y="2860811"/>
            <a:ext cx="3840480" cy="235253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8011265-A739-4D6A-B564-3466DE950AD9}"/>
              </a:ext>
            </a:extLst>
          </p:cNvPr>
          <p:cNvSpPr txBox="1"/>
          <p:nvPr/>
        </p:nvSpPr>
        <p:spPr>
          <a:xfrm flipH="1">
            <a:off x="4678689" y="143253"/>
            <a:ext cx="3880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F9EF59A-42E3-4423-84C7-CB1AADC37102}"/>
              </a:ext>
            </a:extLst>
          </p:cNvPr>
          <p:cNvSpPr txBox="1"/>
          <p:nvPr/>
        </p:nvSpPr>
        <p:spPr>
          <a:xfrm>
            <a:off x="8070244" y="2869242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LVR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53D02CD-D790-4EB8-8390-A779FC1261D8}"/>
              </a:ext>
            </a:extLst>
          </p:cNvPr>
          <p:cNvSpPr txBox="1"/>
          <p:nvPr/>
        </p:nvSpPr>
        <p:spPr>
          <a:xfrm>
            <a:off x="8070244" y="443387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LVRB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A7067FAA-C6B5-423F-A66F-8848F18A8F2F}"/>
              </a:ext>
            </a:extLst>
          </p:cNvPr>
          <p:cNvSpPr/>
          <p:nvPr/>
        </p:nvSpPr>
        <p:spPr>
          <a:xfrm>
            <a:off x="6136165" y="1112572"/>
            <a:ext cx="182880" cy="1458345"/>
          </a:xfrm>
          <a:prstGeom prst="rect">
            <a:avLst/>
          </a:prstGeom>
          <a:noFill/>
          <a:ln w="2222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ED70EB6-81CC-4FAB-8E40-A468D53E4575}"/>
              </a:ext>
            </a:extLst>
          </p:cNvPr>
          <p:cNvSpPr txBox="1"/>
          <p:nvPr/>
        </p:nvSpPr>
        <p:spPr>
          <a:xfrm>
            <a:off x="229001" y="6524300"/>
            <a:ext cx="22791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archenko et. al.,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1E98479-2BA0-441F-BAA8-B287BB9C1BFB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00" r="22200" b="8097"/>
          <a:stretch/>
        </p:blipFill>
        <p:spPr>
          <a:xfrm>
            <a:off x="275344" y="1040824"/>
            <a:ext cx="2385415" cy="346360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578185E8-8040-446B-A683-39703DF6D673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938" r="1878" b="6397"/>
          <a:stretch/>
        </p:blipFill>
        <p:spPr>
          <a:xfrm>
            <a:off x="3251531" y="2882225"/>
            <a:ext cx="297949" cy="1513654"/>
          </a:xfrm>
          <a:prstGeom prst="rect">
            <a:avLst/>
          </a:prstGeom>
        </p:spPr>
      </p:pic>
      <p:sp>
        <p:nvSpPr>
          <p:cNvPr id="41" name="Right Brace 40">
            <a:extLst>
              <a:ext uri="{FF2B5EF4-FFF2-40B4-BE49-F238E27FC236}">
                <a16:creationId xmlns:a16="http://schemas.microsoft.com/office/drawing/2014/main" id="{000300D4-B657-484D-BFCA-4D0FEB446C97}"/>
              </a:ext>
            </a:extLst>
          </p:cNvPr>
          <p:cNvSpPr/>
          <p:nvPr/>
        </p:nvSpPr>
        <p:spPr>
          <a:xfrm>
            <a:off x="2649792" y="1140631"/>
            <a:ext cx="45719" cy="266424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4601450-FECA-4B5F-9CA6-24EF57E5AD97}"/>
              </a:ext>
            </a:extLst>
          </p:cNvPr>
          <p:cNvSpPr txBox="1"/>
          <p:nvPr/>
        </p:nvSpPr>
        <p:spPr>
          <a:xfrm>
            <a:off x="275345" y="879021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LVRA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07F2D66-56F5-4806-A4FA-32D2F6920BBE}"/>
              </a:ext>
            </a:extLst>
          </p:cNvPr>
          <p:cNvSpPr txBox="1"/>
          <p:nvPr/>
        </p:nvSpPr>
        <p:spPr>
          <a:xfrm>
            <a:off x="841608" y="879021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LVRB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FC43322-ADDB-437E-8A89-8E210C926C3E}"/>
              </a:ext>
            </a:extLst>
          </p:cNvPr>
          <p:cNvSpPr txBox="1"/>
          <p:nvPr/>
        </p:nvSpPr>
        <p:spPr>
          <a:xfrm>
            <a:off x="1426706" y="879021"/>
            <a:ext cx="6864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HMOX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967216A-BDAD-49ED-A04E-961850C7AD27}"/>
              </a:ext>
            </a:extLst>
          </p:cNvPr>
          <p:cNvSpPr txBox="1"/>
          <p:nvPr/>
        </p:nvSpPr>
        <p:spPr>
          <a:xfrm>
            <a:off x="1984403" y="879021"/>
            <a:ext cx="6864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HMOX2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DD70C7A4-82EF-4A02-9270-7963714597F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11" r="12332" b="10433"/>
          <a:stretch/>
        </p:blipFill>
        <p:spPr>
          <a:xfrm>
            <a:off x="2891099" y="1368777"/>
            <a:ext cx="956248" cy="1188720"/>
          </a:xfrm>
          <a:prstGeom prst="rect">
            <a:avLst/>
          </a:prstGeom>
          <a:ln w="22225" cmpd="sng">
            <a:noFill/>
          </a:ln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10C03511-3FD6-4823-AA0C-3D88AA7AF8D5}"/>
              </a:ext>
            </a:extLst>
          </p:cNvPr>
          <p:cNvSpPr txBox="1"/>
          <p:nvPr/>
        </p:nvSpPr>
        <p:spPr>
          <a:xfrm>
            <a:off x="3759608" y="1843828"/>
            <a:ext cx="7505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S-578T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725A9E6-4F76-4735-8245-F4A70C216E34}"/>
              </a:ext>
            </a:extLst>
          </p:cNvPr>
          <p:cNvSpPr txBox="1"/>
          <p:nvPr/>
        </p:nvSpPr>
        <p:spPr>
          <a:xfrm>
            <a:off x="3759608" y="1609839"/>
            <a:ext cx="10390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794553B-6CA8-40F7-AE11-D5CE2B258E08}"/>
              </a:ext>
            </a:extLst>
          </p:cNvPr>
          <p:cNvSpPr txBox="1"/>
          <p:nvPr/>
        </p:nvSpPr>
        <p:spPr>
          <a:xfrm>
            <a:off x="3759608" y="2321780"/>
            <a:ext cx="5309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47D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670A52B-086B-4947-8C3B-0CD93EC08A48}"/>
              </a:ext>
            </a:extLst>
          </p:cNvPr>
          <p:cNvSpPr txBox="1"/>
          <p:nvPr/>
        </p:nvSpPr>
        <p:spPr>
          <a:xfrm>
            <a:off x="3759608" y="2088864"/>
            <a:ext cx="6014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T549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0C4C269-1258-4E82-B17E-10BAEDC3E52E}"/>
              </a:ext>
            </a:extLst>
          </p:cNvPr>
          <p:cNvSpPr txBox="1"/>
          <p:nvPr/>
        </p:nvSpPr>
        <p:spPr>
          <a:xfrm>
            <a:off x="3759608" y="1368777"/>
            <a:ext cx="5693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1E1B9F65-6F81-4FF3-BDD3-54E479C79E2B}"/>
              </a:ext>
            </a:extLst>
          </p:cNvPr>
          <p:cNvSpPr txBox="1"/>
          <p:nvPr/>
        </p:nvSpPr>
        <p:spPr>
          <a:xfrm>
            <a:off x="3478105" y="3059851"/>
            <a:ext cx="353943" cy="115672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xpression, Log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9206B87-0BF9-43E2-A8C4-AD1DC0A9ECBD}"/>
              </a:ext>
            </a:extLst>
          </p:cNvPr>
          <p:cNvSpPr txBox="1"/>
          <p:nvPr/>
        </p:nvSpPr>
        <p:spPr>
          <a:xfrm>
            <a:off x="2847516" y="2554768"/>
            <a:ext cx="10534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reast cancer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B17216E-F5B6-428E-A3F2-CAC6F0E37131}"/>
              </a:ext>
            </a:extLst>
          </p:cNvPr>
          <p:cNvSpPr txBox="1"/>
          <p:nvPr/>
        </p:nvSpPr>
        <p:spPr>
          <a:xfrm flipH="1">
            <a:off x="47348" y="143253"/>
            <a:ext cx="3880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7BDE203-C555-40D3-B6E3-8F6C7D5C0584}"/>
              </a:ext>
            </a:extLst>
          </p:cNvPr>
          <p:cNvSpPr txBox="1"/>
          <p:nvPr/>
        </p:nvSpPr>
        <p:spPr>
          <a:xfrm rot="-2700000">
            <a:off x="2798776" y="1037009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LVR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75F0F59-4B04-4BAA-8868-74E6D9AD112B}"/>
              </a:ext>
            </a:extLst>
          </p:cNvPr>
          <p:cNvSpPr txBox="1"/>
          <p:nvPr/>
        </p:nvSpPr>
        <p:spPr>
          <a:xfrm rot="-2700000">
            <a:off x="3054539" y="1037009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LVR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CA5A8F8-22E0-4221-9BD5-9082D48C043A}"/>
              </a:ext>
            </a:extLst>
          </p:cNvPr>
          <p:cNvSpPr txBox="1"/>
          <p:nvPr/>
        </p:nvSpPr>
        <p:spPr>
          <a:xfrm rot="-2700000">
            <a:off x="3293267" y="1023974"/>
            <a:ext cx="6864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HMOX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16E7034-05A3-4BF0-B2A8-C1983FEEB554}"/>
              </a:ext>
            </a:extLst>
          </p:cNvPr>
          <p:cNvSpPr txBox="1"/>
          <p:nvPr/>
        </p:nvSpPr>
        <p:spPr>
          <a:xfrm rot="-2700000">
            <a:off x="3528463" y="1023974"/>
            <a:ext cx="6864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HMOX2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54569D3-E9E5-4927-9AD7-27EB3FEAF7D5}"/>
              </a:ext>
            </a:extLst>
          </p:cNvPr>
          <p:cNvSpPr/>
          <p:nvPr/>
        </p:nvSpPr>
        <p:spPr>
          <a:xfrm>
            <a:off x="342183" y="1148582"/>
            <a:ext cx="2240413" cy="261609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B809F064-6D23-470E-B2C6-790C28A24343}"/>
              </a:ext>
            </a:extLst>
          </p:cNvPr>
          <p:cNvCxnSpPr/>
          <p:nvPr/>
        </p:nvCxnSpPr>
        <p:spPr>
          <a:xfrm>
            <a:off x="2666215" y="1475729"/>
            <a:ext cx="0" cy="463555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D0E5A01F-E834-4E5E-8A5C-E54B548FBE59}"/>
              </a:ext>
            </a:extLst>
          </p:cNvPr>
          <p:cNvCxnSpPr/>
          <p:nvPr/>
        </p:nvCxnSpPr>
        <p:spPr>
          <a:xfrm>
            <a:off x="2670809" y="1939284"/>
            <a:ext cx="22029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7" name="Picture 46">
            <a:extLst>
              <a:ext uri="{FF2B5EF4-FFF2-40B4-BE49-F238E27FC236}">
                <a16:creationId xmlns:a16="http://schemas.microsoft.com/office/drawing/2014/main" id="{61F23D87-2A75-462B-88A9-DCCAE132CC77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70" t="20161" r="14506" b="15206"/>
          <a:stretch/>
        </p:blipFill>
        <p:spPr>
          <a:xfrm>
            <a:off x="9581363" y="4646368"/>
            <a:ext cx="2111025" cy="2011680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BE1FB929-ABC7-4E83-B0D8-F9A4AE46F305}"/>
              </a:ext>
            </a:extLst>
          </p:cNvPr>
          <p:cNvSpPr txBox="1"/>
          <p:nvPr/>
        </p:nvSpPr>
        <p:spPr>
          <a:xfrm>
            <a:off x="8815348" y="6156600"/>
            <a:ext cx="11251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pithelial basal</a:t>
            </a:r>
          </a:p>
        </p:txBody>
      </p: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BADDEC9F-95FC-47A9-98BF-723B60FCCAE2}"/>
              </a:ext>
            </a:extLst>
          </p:cNvPr>
          <p:cNvCxnSpPr/>
          <p:nvPr/>
        </p:nvCxnSpPr>
        <p:spPr>
          <a:xfrm flipV="1">
            <a:off x="9637485" y="5710203"/>
            <a:ext cx="615264" cy="513567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CC18B7C0-CD01-48C7-96E6-FFEC3B6B024D}"/>
              </a:ext>
            </a:extLst>
          </p:cNvPr>
          <p:cNvSpPr txBox="1"/>
          <p:nvPr/>
        </p:nvSpPr>
        <p:spPr>
          <a:xfrm>
            <a:off x="11190720" y="6100659"/>
            <a:ext cx="11251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yeloid </a:t>
            </a:r>
          </a:p>
        </p:txBody>
      </p: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4A3364DE-D8D5-4CB4-BDBD-BD046BED5165}"/>
              </a:ext>
            </a:extLst>
          </p:cNvPr>
          <p:cNvCxnSpPr>
            <a:stCxn id="59" idx="1"/>
          </p:cNvCxnSpPr>
          <p:nvPr/>
        </p:nvCxnSpPr>
        <p:spPr>
          <a:xfrm flipH="1" flipV="1">
            <a:off x="11084970" y="5966987"/>
            <a:ext cx="105750" cy="24139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F0826C7C-D3CA-4FBC-BA2F-713D94A40D55}"/>
              </a:ext>
            </a:extLst>
          </p:cNvPr>
          <p:cNvSpPr txBox="1"/>
          <p:nvPr/>
        </p:nvSpPr>
        <p:spPr>
          <a:xfrm>
            <a:off x="9224561" y="5500022"/>
            <a:ext cx="5314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iCAF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DC64675-FD69-446B-86A4-DDAC8DA0DAF5}"/>
              </a:ext>
            </a:extLst>
          </p:cNvPr>
          <p:cNvSpPr txBox="1"/>
          <p:nvPr/>
        </p:nvSpPr>
        <p:spPr>
          <a:xfrm>
            <a:off x="9138076" y="6517378"/>
            <a:ext cx="11251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pithelial basal</a:t>
            </a:r>
          </a:p>
          <a:p>
            <a:r>
              <a: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cling</a:t>
            </a:r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300FB7BB-5234-46AE-8546-6F060DBABBAF}"/>
              </a:ext>
            </a:extLst>
          </p:cNvPr>
          <p:cNvCxnSpPr/>
          <p:nvPr/>
        </p:nvCxnSpPr>
        <p:spPr>
          <a:xfrm flipV="1">
            <a:off x="9968038" y="6038534"/>
            <a:ext cx="615264" cy="513567"/>
          </a:xfrm>
          <a:prstGeom prst="straightConnector1">
            <a:avLst/>
          </a:prstGeom>
          <a:ln w="254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A3BF9829-88E6-4216-934E-DB3D68753FE9}"/>
              </a:ext>
            </a:extLst>
          </p:cNvPr>
          <p:cNvSpPr txBox="1"/>
          <p:nvPr/>
        </p:nvSpPr>
        <p:spPr>
          <a:xfrm>
            <a:off x="9084009" y="4720335"/>
            <a:ext cx="11251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ature Epithelial luminal</a:t>
            </a:r>
          </a:p>
        </p:txBody>
      </p: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B43A3E56-894B-479D-AE85-0D4AFE2AA1C5}"/>
              </a:ext>
            </a:extLst>
          </p:cNvPr>
          <p:cNvCxnSpPr>
            <a:cxnSpLocks/>
          </p:cNvCxnSpPr>
          <p:nvPr/>
        </p:nvCxnSpPr>
        <p:spPr>
          <a:xfrm>
            <a:off x="9808548" y="4939710"/>
            <a:ext cx="136569" cy="18657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A962B6C4-1EF3-4C70-B226-D0F6842294A0}"/>
              </a:ext>
            </a:extLst>
          </p:cNvPr>
          <p:cNvSpPr txBox="1"/>
          <p:nvPr/>
        </p:nvSpPr>
        <p:spPr>
          <a:xfrm>
            <a:off x="11136211" y="4570120"/>
            <a:ext cx="8990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mmune cells</a:t>
            </a:r>
          </a:p>
        </p:txBody>
      </p: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F0108E81-5DF8-4EC8-A6F6-C469E077AD44}"/>
              </a:ext>
            </a:extLst>
          </p:cNvPr>
          <p:cNvCxnSpPr/>
          <p:nvPr/>
        </p:nvCxnSpPr>
        <p:spPr>
          <a:xfrm flipH="1">
            <a:off x="10820438" y="4818368"/>
            <a:ext cx="631522" cy="26175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1720261D-C489-47AF-9FEA-D8B0D235902E}"/>
              </a:ext>
            </a:extLst>
          </p:cNvPr>
          <p:cNvSpPr txBox="1"/>
          <p:nvPr/>
        </p:nvSpPr>
        <p:spPr>
          <a:xfrm>
            <a:off x="11411041" y="5604162"/>
            <a:ext cx="11251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Myoepithelial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26ADE21D-097F-4343-B35B-F21DB633E038}"/>
              </a:ext>
            </a:extLst>
          </p:cNvPr>
          <p:cNvCxnSpPr>
            <a:stCxn id="68" idx="1"/>
          </p:cNvCxnSpPr>
          <p:nvPr/>
        </p:nvCxnSpPr>
        <p:spPr>
          <a:xfrm flipH="1" flipV="1">
            <a:off x="10986411" y="5694090"/>
            <a:ext cx="424630" cy="1779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65BCD9CC-685F-400C-9A08-7371B1BC8D75}"/>
              </a:ext>
            </a:extLst>
          </p:cNvPr>
          <p:cNvSpPr txBox="1"/>
          <p:nvPr/>
        </p:nvSpPr>
        <p:spPr>
          <a:xfrm flipH="1">
            <a:off x="9078960" y="143253"/>
            <a:ext cx="3880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0C16140-BC77-42BE-80D4-270BFF90760B}"/>
              </a:ext>
            </a:extLst>
          </p:cNvPr>
          <p:cNvSpPr txBox="1"/>
          <p:nvPr/>
        </p:nvSpPr>
        <p:spPr>
          <a:xfrm flipH="1">
            <a:off x="9078960" y="4374504"/>
            <a:ext cx="3880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A7161BCD-3C70-4343-9622-67245EA4136C}"/>
              </a:ext>
            </a:extLst>
          </p:cNvPr>
          <p:cNvSpPr/>
          <p:nvPr/>
        </p:nvSpPr>
        <p:spPr>
          <a:xfrm>
            <a:off x="5951292" y="1112572"/>
            <a:ext cx="182880" cy="1458345"/>
          </a:xfrm>
          <a:prstGeom prst="rect">
            <a:avLst/>
          </a:prstGeom>
          <a:noFill/>
          <a:ln w="222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DC7CA3F6-8505-468B-AD03-F440BAD81531}"/>
              </a:ext>
            </a:extLst>
          </p:cNvPr>
          <p:cNvSpPr/>
          <p:nvPr/>
        </p:nvSpPr>
        <p:spPr>
          <a:xfrm>
            <a:off x="6113995" y="3683975"/>
            <a:ext cx="182880" cy="1458345"/>
          </a:xfrm>
          <a:prstGeom prst="rect">
            <a:avLst/>
          </a:prstGeom>
          <a:noFill/>
          <a:ln w="2222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2FD9FB7A-6352-4578-BCC5-08E975336637}"/>
              </a:ext>
            </a:extLst>
          </p:cNvPr>
          <p:cNvSpPr/>
          <p:nvPr/>
        </p:nvSpPr>
        <p:spPr>
          <a:xfrm>
            <a:off x="5929969" y="3683975"/>
            <a:ext cx="182880" cy="1458345"/>
          </a:xfrm>
          <a:prstGeom prst="rect">
            <a:avLst/>
          </a:prstGeom>
          <a:noFill/>
          <a:ln w="222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Oval 78">
            <a:extLst>
              <a:ext uri="{FF2B5EF4-FFF2-40B4-BE49-F238E27FC236}">
                <a16:creationId xmlns:a16="http://schemas.microsoft.com/office/drawing/2014/main" id="{F6844BCF-2654-44B1-AE92-85061D0DF83E}"/>
              </a:ext>
            </a:extLst>
          </p:cNvPr>
          <p:cNvSpPr/>
          <p:nvPr/>
        </p:nvSpPr>
        <p:spPr>
          <a:xfrm>
            <a:off x="10447949" y="1489954"/>
            <a:ext cx="337704" cy="328331"/>
          </a:xfrm>
          <a:prstGeom prst="ellipse">
            <a:avLst/>
          </a:prstGeom>
          <a:noFill/>
          <a:ln w="1905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Oval 79">
            <a:extLst>
              <a:ext uri="{FF2B5EF4-FFF2-40B4-BE49-F238E27FC236}">
                <a16:creationId xmlns:a16="http://schemas.microsoft.com/office/drawing/2014/main" id="{64BFB195-EB25-4380-AFC4-3473EF408C44}"/>
              </a:ext>
            </a:extLst>
          </p:cNvPr>
          <p:cNvSpPr/>
          <p:nvPr/>
        </p:nvSpPr>
        <p:spPr>
          <a:xfrm>
            <a:off x="10442046" y="3355644"/>
            <a:ext cx="337704" cy="328331"/>
          </a:xfrm>
          <a:prstGeom prst="ellipse">
            <a:avLst/>
          </a:prstGeom>
          <a:noFill/>
          <a:ln w="1905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0014204-DFEE-4603-99B9-1DA09ACA05F9}"/>
              </a:ext>
            </a:extLst>
          </p:cNvPr>
          <p:cNvSpPr txBox="1"/>
          <p:nvPr/>
        </p:nvSpPr>
        <p:spPr>
          <a:xfrm>
            <a:off x="10811498" y="2441944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LVRA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E2E4F44B-81DC-4764-A752-1103EFAA031D}"/>
              </a:ext>
            </a:extLst>
          </p:cNvPr>
          <p:cNvSpPr txBox="1"/>
          <p:nvPr/>
        </p:nvSpPr>
        <p:spPr>
          <a:xfrm>
            <a:off x="10811498" y="292314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LVR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37086EF-77BB-4FCE-8943-0356F8A38BEF}"/>
              </a:ext>
            </a:extLst>
          </p:cNvPr>
          <p:cNvSpPr txBox="1"/>
          <p:nvPr/>
        </p:nvSpPr>
        <p:spPr>
          <a:xfrm>
            <a:off x="4770266" y="3519809"/>
            <a:ext cx="353943" cy="115833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expression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1BFCFE8D-5A46-4817-B625-46DCE1EE1B3C}"/>
              </a:ext>
            </a:extLst>
          </p:cNvPr>
          <p:cNvSpPr txBox="1"/>
          <p:nvPr/>
        </p:nvSpPr>
        <p:spPr>
          <a:xfrm>
            <a:off x="4770266" y="1128341"/>
            <a:ext cx="353943" cy="115833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expression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D825E085-0A35-461A-AB6B-03ED06A1B3DF}"/>
              </a:ext>
            </a:extLst>
          </p:cNvPr>
          <p:cNvSpPr txBox="1"/>
          <p:nvPr/>
        </p:nvSpPr>
        <p:spPr>
          <a:xfrm rot="3259049">
            <a:off x="6693191" y="5365885"/>
            <a:ext cx="81260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NK_cells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5DB0CF57-D04E-4E19-ACC0-06186E7D54AA}"/>
              </a:ext>
            </a:extLst>
          </p:cNvPr>
          <p:cNvSpPr txBox="1"/>
          <p:nvPr/>
        </p:nvSpPr>
        <p:spPr>
          <a:xfrm>
            <a:off x="7391441" y="5077543"/>
            <a:ext cx="18473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700" b="1" dirty="0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5633FD8C-D1DA-40DC-9D96-2065756BDFA7}"/>
              </a:ext>
            </a:extLst>
          </p:cNvPr>
          <p:cNvSpPr txBox="1"/>
          <p:nvPr/>
        </p:nvSpPr>
        <p:spPr>
          <a:xfrm rot="3259049">
            <a:off x="5238641" y="5393406"/>
            <a:ext cx="88036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D4+ </a:t>
            </a:r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T_cells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9D262E76-BD2E-474D-B184-02C99CB6E3CF}"/>
              </a:ext>
            </a:extLst>
          </p:cNvPr>
          <p:cNvSpPr txBox="1"/>
          <p:nvPr/>
        </p:nvSpPr>
        <p:spPr>
          <a:xfrm rot="3259049">
            <a:off x="5642054" y="5289893"/>
            <a:ext cx="66877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Endothelial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A99A4C86-65D6-4AFB-A158-1C514204B567}"/>
              </a:ext>
            </a:extLst>
          </p:cNvPr>
          <p:cNvSpPr txBox="1"/>
          <p:nvPr/>
        </p:nvSpPr>
        <p:spPr>
          <a:xfrm rot="3259049">
            <a:off x="5414223" y="5393406"/>
            <a:ext cx="88036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D8+ </a:t>
            </a:r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T_cells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FEA01706-5B7B-48EE-AEDF-2EDC9DC65BD4}"/>
              </a:ext>
            </a:extLst>
          </p:cNvPr>
          <p:cNvSpPr txBox="1"/>
          <p:nvPr/>
        </p:nvSpPr>
        <p:spPr>
          <a:xfrm rot="3259049">
            <a:off x="5773966" y="5368017"/>
            <a:ext cx="8739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Epithelial_Basal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559F257-1866-40B6-9FA9-5237B60F3C33}"/>
              </a:ext>
            </a:extLst>
          </p:cNvPr>
          <p:cNvSpPr txBox="1"/>
          <p:nvPr/>
        </p:nvSpPr>
        <p:spPr>
          <a:xfrm rot="3259049">
            <a:off x="5873515" y="5506686"/>
            <a:ext cx="12474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Epithelial_Basal_Cycling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45C6D4D8-8B71-4DBF-9B0A-66B0DE71BB38}"/>
              </a:ext>
            </a:extLst>
          </p:cNvPr>
          <p:cNvSpPr txBox="1"/>
          <p:nvPr/>
        </p:nvSpPr>
        <p:spPr>
          <a:xfrm rot="3259049">
            <a:off x="6043295" y="5538586"/>
            <a:ext cx="13244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Epithelial_Luminal_Mature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D86AE32C-28E1-4A32-97E2-6D541493B879}"/>
              </a:ext>
            </a:extLst>
          </p:cNvPr>
          <p:cNvSpPr txBox="1"/>
          <p:nvPr/>
        </p:nvSpPr>
        <p:spPr>
          <a:xfrm rot="3259049">
            <a:off x="6448083" y="5456585"/>
            <a:ext cx="10359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Myoepithelial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42DC662F-4B8D-47C2-8711-31CD8E92185B}"/>
              </a:ext>
            </a:extLst>
          </p:cNvPr>
          <p:cNvSpPr txBox="1"/>
          <p:nvPr/>
        </p:nvSpPr>
        <p:spPr>
          <a:xfrm rot="3259049">
            <a:off x="5125943" y="5261899"/>
            <a:ext cx="5565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B_cells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D66F23EF-F427-40F2-9E9D-3875E5C3A667}"/>
              </a:ext>
            </a:extLst>
          </p:cNvPr>
          <p:cNvSpPr txBox="1"/>
          <p:nvPr/>
        </p:nvSpPr>
        <p:spPr>
          <a:xfrm rot="3259049">
            <a:off x="7101946" y="5383801"/>
            <a:ext cx="8567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Plasma_cells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47EA505-FD01-47F9-85FD-676599AED4E8}"/>
              </a:ext>
            </a:extLst>
          </p:cNvPr>
          <p:cNvSpPr txBox="1"/>
          <p:nvPr/>
        </p:nvSpPr>
        <p:spPr>
          <a:xfrm rot="3259049">
            <a:off x="7406664" y="5428665"/>
            <a:ext cx="967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T_ cells cycling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40F196E4-0787-4702-A52D-6D2ACED6524E}"/>
              </a:ext>
            </a:extLst>
          </p:cNvPr>
          <p:cNvSpPr txBox="1"/>
          <p:nvPr/>
        </p:nvSpPr>
        <p:spPr>
          <a:xfrm rot="3259049">
            <a:off x="7317725" y="5280101"/>
            <a:ext cx="6013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T_Regs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A23CDBDF-CB04-49E5-A644-C8D4DD8A6CF3}"/>
              </a:ext>
            </a:extLst>
          </p:cNvPr>
          <p:cNvSpPr txBox="1"/>
          <p:nvPr/>
        </p:nvSpPr>
        <p:spPr>
          <a:xfrm rot="3259049">
            <a:off x="7853085" y="5291255"/>
            <a:ext cx="6288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Tfh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B1DD9BE5-267C-46FC-9860-769D708E305A}"/>
              </a:ext>
            </a:extLst>
          </p:cNvPr>
          <p:cNvSpPr txBox="1"/>
          <p:nvPr/>
        </p:nvSpPr>
        <p:spPr>
          <a:xfrm rot="3259049">
            <a:off x="7530233" y="5548499"/>
            <a:ext cx="12622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T_cells_unassigned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195B1B7D-70DF-4A3E-90B8-7322BC93E6EF}"/>
              </a:ext>
            </a:extLst>
          </p:cNvPr>
          <p:cNvSpPr txBox="1"/>
          <p:nvPr/>
        </p:nvSpPr>
        <p:spPr>
          <a:xfrm rot="3259049">
            <a:off x="8042347" y="5261899"/>
            <a:ext cx="5565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dPVL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40455D4C-3F97-445C-9DF8-D7F55C7A64CE}"/>
              </a:ext>
            </a:extLst>
          </p:cNvPr>
          <p:cNvSpPr txBox="1"/>
          <p:nvPr/>
        </p:nvSpPr>
        <p:spPr>
          <a:xfrm rot="3259049">
            <a:off x="8226080" y="5261899"/>
            <a:ext cx="5565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iCAFs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DCE42BAB-18DD-48DA-9F4C-CBA253D99202}"/>
              </a:ext>
            </a:extLst>
          </p:cNvPr>
          <p:cNvSpPr txBox="1"/>
          <p:nvPr/>
        </p:nvSpPr>
        <p:spPr>
          <a:xfrm rot="3259049">
            <a:off x="6356001" y="5300539"/>
            <a:ext cx="65170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Myeloid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103466EB-3B0F-4D39-90BE-A6DA424512E4}"/>
              </a:ext>
            </a:extLst>
          </p:cNvPr>
          <p:cNvSpPr txBox="1"/>
          <p:nvPr/>
        </p:nvSpPr>
        <p:spPr>
          <a:xfrm rot="3259049">
            <a:off x="6887999" y="5365885"/>
            <a:ext cx="81260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NKT_cells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4611C747-0ACD-4B49-B77B-00698D3F6F25}"/>
              </a:ext>
            </a:extLst>
          </p:cNvPr>
          <p:cNvSpPr txBox="1"/>
          <p:nvPr/>
        </p:nvSpPr>
        <p:spPr>
          <a:xfrm rot="3259049">
            <a:off x="8368513" y="5365885"/>
            <a:ext cx="81260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lmPVL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B264E9B7-B00E-40EC-8EEC-D67BF3EB91C8}"/>
              </a:ext>
            </a:extLst>
          </p:cNvPr>
          <p:cNvSpPr txBox="1"/>
          <p:nvPr/>
        </p:nvSpPr>
        <p:spPr>
          <a:xfrm rot="3259049">
            <a:off x="8555254" y="5365885"/>
            <a:ext cx="81260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myCAFs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Oval 83">
            <a:extLst>
              <a:ext uri="{FF2B5EF4-FFF2-40B4-BE49-F238E27FC236}">
                <a16:creationId xmlns:a16="http://schemas.microsoft.com/office/drawing/2014/main" id="{BF7EA3DD-73C2-474F-9B6C-AD37548A2CD4}"/>
              </a:ext>
            </a:extLst>
          </p:cNvPr>
          <p:cNvSpPr/>
          <p:nvPr/>
        </p:nvSpPr>
        <p:spPr>
          <a:xfrm flipV="1">
            <a:off x="9971904" y="3229128"/>
            <a:ext cx="274320" cy="274320"/>
          </a:xfrm>
          <a:prstGeom prst="ellipse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Oval 105">
            <a:extLst>
              <a:ext uri="{FF2B5EF4-FFF2-40B4-BE49-F238E27FC236}">
                <a16:creationId xmlns:a16="http://schemas.microsoft.com/office/drawing/2014/main" id="{F1ECB38A-C009-4AE2-8A57-E33F214245FA}"/>
              </a:ext>
            </a:extLst>
          </p:cNvPr>
          <p:cNvSpPr/>
          <p:nvPr/>
        </p:nvSpPr>
        <p:spPr>
          <a:xfrm flipV="1">
            <a:off x="10029054" y="1279678"/>
            <a:ext cx="274320" cy="274320"/>
          </a:xfrm>
          <a:prstGeom prst="ellipse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9484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6</TotalTime>
  <Words>83</Words>
  <Application>Microsoft Office PowerPoint</Application>
  <PresentationFormat>Widescreen</PresentationFormat>
  <Paragraphs>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hou, Wadie</dc:creator>
  <cp:lastModifiedBy>Natalia</cp:lastModifiedBy>
  <cp:revision>35</cp:revision>
  <dcterms:created xsi:type="dcterms:W3CDTF">2023-06-23T13:15:47Z</dcterms:created>
  <dcterms:modified xsi:type="dcterms:W3CDTF">2025-08-14T15:31:14Z</dcterms:modified>
</cp:coreProperties>
</file>